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11840-B4AA-4954-AFEE-7DE2BC7346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F410A-EE35-473D-B2BF-6FEF408391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0F6D19-7D5D-4495-B768-1665241ECE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A1456-A066-4D79-A04B-E23B084BDC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41BB4-A961-428C-A9AD-E8C3D5BCFA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64938-F915-4D45-ACB8-B3A3DD9423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5FAD2-F386-4ADC-83B1-83F5C94F9F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324340-05FF-48F0-B3BF-778B88AAD1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E7551-BB78-4BE6-A9EC-0992E63799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AE1C2-2629-41A8-B1AB-0D72B6005F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D6A80-A836-4E62-A08C-57F1EF3511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C8E72-C91C-4392-A0BE-F8B63A479D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F1BE0A-2C4D-487B-A227-0851AD2DFE49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5920" y="974880"/>
          <a:ext cx="6553080" cy="2995560"/>
        </p:xfrm>
        <a:graphic>
          <a:graphicData uri="http://schemas.openxmlformats.org/drawingml/2006/table">
            <a:tbl>
              <a:tblPr/>
              <a:tblGrid>
                <a:gridCol w="2095560"/>
                <a:gridCol w="1236600"/>
                <a:gridCol w="912960"/>
                <a:gridCol w="296640"/>
                <a:gridCol w="1663920"/>
                <a:gridCol w="347400"/>
              </a:tblGrid>
              <a:tr h="30924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inical-pathological paramet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ivariate analy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ltivariate analy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85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e (n=10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92 (0.582, 2.4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-stage (n=10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652 (1.254, 5.60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083 (1.252, 7.59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ymph-node involvemen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651 (0.988, 7.11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661 (0.875, 8.09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mor-Grad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73 (0.476, 2.41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strogen receptor stat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30 (0.418, 2.07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75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clear KIF20A sco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141 (1, 4.58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447 (1.014, 5.90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252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115920" y="4435560"/>
          <a:ext cx="6553080" cy="2593800"/>
        </p:xfrm>
        <a:graphic>
          <a:graphicData uri="http://schemas.openxmlformats.org/drawingml/2006/table">
            <a:tbl>
              <a:tblPr/>
              <a:tblGrid>
                <a:gridCol w="2158920"/>
                <a:gridCol w="1416240"/>
                <a:gridCol w="353880"/>
                <a:gridCol w="576360"/>
                <a:gridCol w="1385640"/>
                <a:gridCol w="576360"/>
                <a:gridCol w="85680"/>
              </a:tblGrid>
              <a:tr h="19980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inical-pathological paramet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ivariate analy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ltivariate analy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72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e (n=10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04 (0.361, 1.79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-stage (n=10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109 (1.386, 6.97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286 (1.239, 8.7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ymph-node involvemen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977 (0.999, 8.86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064 (0.863, 10.87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mor-Grad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3 (0.570, 3.58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strogen receptor stat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17 (0.342, 1.94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872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clear KIF20A sco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695 (1.165, 6.23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767 (1.061, 7.21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Box 1"/>
          <p:cNvSpPr/>
          <p:nvPr/>
        </p:nvSpPr>
        <p:spPr>
          <a:xfrm>
            <a:off x="95760" y="641520"/>
            <a:ext cx="1563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99360" y="4094280"/>
            <a:ext cx="235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isease-specific survival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99000" y="115920"/>
            <a:ext cx="187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ll patients (n=100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4603680" y="9510840"/>
            <a:ext cx="210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0T13:30:06Z</dcterms:created>
  <dc:creator>Khongkow, Pasarat</dc:creator>
  <dc:description/>
  <dc:language>en-US</dc:language>
  <cp:lastModifiedBy>Eric Lam</cp:lastModifiedBy>
  <cp:lastPrinted>2015-04-01T15:47:29Z</cp:lastPrinted>
  <dcterms:modified xsi:type="dcterms:W3CDTF">2015-04-01T21:02:48Z</dcterms:modified>
  <cp:revision>105</cp:revision>
  <dc:subject/>
  <dc:title>PowerPoint Presentation</dc:title>
</cp:coreProperties>
</file>